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9" r:id="rId2"/>
    <p:sldId id="271" r:id="rId3"/>
    <p:sldId id="270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909" autoAdjust="0"/>
  </p:normalViewPr>
  <p:slideViewPr>
    <p:cSldViewPr snapToGrid="0">
      <p:cViewPr varScale="1">
        <p:scale>
          <a:sx n="105" d="100"/>
          <a:sy n="105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5DD264-B73A-4C4B-B7E5-7EBC6CCA2AAD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0AB5B5-F1AA-4916-97AF-777ED1137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78197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E7309E3-19BA-8C48-D494-F3EFA94685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0BBA1692-3B22-1769-A4EC-CBE47B83DC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3E0B3E7-7A77-240E-410D-7AC63A1D0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21E2CC-5C82-7FC1-5F22-68412855F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8C83705-8D4C-3CB6-1B50-A53A434ED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011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60BF47F-B2B1-CD06-330E-CA1A3CF26E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7105CBB-282F-AE8C-DC54-DED61A82C9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2CD145A-EF81-26AB-344C-C44AD2819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8C2EC1B-BBAF-0F54-18F2-CC8C75129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F17E7C3-0CF1-6193-4E96-D8CBBF5E2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9264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2AB7385D-527F-B236-8E72-5909C83BBF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7E2C2FE-1B54-1D8C-9A16-9FCB36AC80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8E6E1EF-2629-075A-C1D0-9E2E874B8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D910E8-88FE-FA7F-11A3-F41878340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98571B6-4912-B6B1-AFB5-D2616C3C9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5351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3E34290-670C-8B67-7FFB-DD12BBE672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AD4C500-80CE-F6EB-287B-3A764E332C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EE7C497-B87D-7A5C-2CF9-96B2E8A98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66F7406-96C8-A010-89C0-D97F6D868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27BA44E-2CEE-B06E-9EB3-5A219830D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6642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52D7A04-8D88-C16F-8FB3-6EDBF865C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76B1003-E2EC-A8E5-BAAA-594C144A53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B5B807C-5691-87DE-7C2A-E4558507D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6FC9CA7-05E6-94C2-1FDD-21553B2E3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A3748D2-2845-FD54-CD4E-1DB7397BD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3143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338E1A0-80B5-63BA-75D9-2F5731C2BB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A8A83A2-56C5-3AF8-316F-57B26F5F35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C8EE107-C16E-D289-18AE-459C1B6456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4E0F532-DE98-556B-BBE5-CFB26EB2A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321A539-D2F1-F743-9264-EF87314FA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8A6AE2A-A08D-61B4-FEDF-397566815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7526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5052D8-6676-3481-FE7C-BCF5BCCBB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4F6B060-82D9-537F-51C4-31D3A7D0FD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9CE596E-0E23-6D87-EC34-F76A2DD94D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2B1024B2-4094-2481-0FDF-0029EFEA03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1A56404-B796-0BBA-8CD0-B84211945A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1FB6C1C-CBCB-C31D-D2C6-F70CB631A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8948CDFD-4A69-B51A-5BA2-59FFAF205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B4B6EB60-B047-E141-83A5-1BBF44EF8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42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114A98C-5A8A-7CA1-47C6-B1CB9F62C6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0390721-D0E6-2823-723B-069B4BE87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EFFE00B5-5B50-02ED-7198-C485EF6CA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33A8FAA3-E728-D3E0-FF41-896E0CA05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6661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28321DB7-0B63-DB8A-C277-F0A782292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62DCDFFE-E7A4-F1F5-A5C7-44685323B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99EA2D60-9EB2-FF95-F367-DC7C40DA8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1184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B2FCDD8-2053-7EBA-EB1F-DE62B95D3B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8C59CF8-5390-BC85-EB2F-2363A5A226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A40C6B9-9709-8C68-E9C8-B152A72DAA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FE17E6E-3492-4C9E-E200-8378D7693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B8F7EA2-D809-9156-E809-6D3B803CA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A121207-20F4-30CA-F1A1-579FF8D5E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7317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0F73DF2-F88C-BFB4-D985-532B49513C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6BCB94D-4EEB-E703-B83A-94274B8E79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DAFD29A-2493-C41D-7812-2905B91649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55D54BB-FCBC-1B9D-DE9C-022F761E1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9502C36-ED62-7822-E121-58BC7B20E9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CA03AE5-56A3-6955-DDC0-9AFC49467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7975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2F9C9927-FEAC-FC5C-F53A-200E6DDB6A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74F1C7D-ABDE-4F5D-0F83-4B028DD4C4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9661FA2-F8BF-FF86-AA00-C83320991A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53FB98-F6B9-4951-8698-BD8B58EDD502}" type="datetimeFigureOut">
              <a:rPr lang="ko-KR" altLang="en-US" smtClean="0"/>
              <a:t>2025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CA74E1-D2A3-503D-7DE0-40761033A0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43837C2-DED0-3FC6-4247-F935FA14BB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B0917D-B8A9-41A9-916E-31B5F9EA39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7938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D3DD4F1-42E9-19D5-1CC1-282EF0AE5F04}"/>
              </a:ext>
            </a:extLst>
          </p:cNvPr>
          <p:cNvSpPr txBox="1"/>
          <p:nvPr/>
        </p:nvSpPr>
        <p:spPr>
          <a:xfrm>
            <a:off x="1287455" y="5503140"/>
            <a:ext cx="870693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1" indent="-457200" algn="just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C-MS/MS and HPLC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kumimoji="0" lang="ko-KR" altLang="ko-KR" sz="16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stilboides</a:t>
            </a:r>
            <a:r>
              <a:rPr kumimoji="0" lang="ko-KR" altLang="ko-KR" sz="16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abularis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oot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tOAc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raction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nfirming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allic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cid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ergenin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ajor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nstituents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dapted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Yoo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ko-KR" altLang="ko-KR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kumimoji="0" lang="ko-KR" altLang="ko-KR" sz="16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lecules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025, 30, 1892.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CCEA0DCF-68A2-1A17-9FAF-00CC982C4D66}"/>
              </a:ext>
            </a:extLst>
          </p:cNvPr>
          <p:cNvGrpSpPr/>
          <p:nvPr/>
        </p:nvGrpSpPr>
        <p:grpSpPr>
          <a:xfrm>
            <a:off x="1287455" y="293486"/>
            <a:ext cx="8706937" cy="5180213"/>
            <a:chOff x="1854383" y="485510"/>
            <a:chExt cx="7787095" cy="4572866"/>
          </a:xfrm>
        </p:grpSpPr>
        <p:pic>
          <p:nvPicPr>
            <p:cNvPr id="9" name="그림 8" descr="도표, 라인, 기술 도면, 평행이(가) 표시된 사진&#10;&#10;AI가 생성한 콘텐츠는 부정확할 수 있습니다.">
              <a:extLst>
                <a:ext uri="{FF2B5EF4-FFF2-40B4-BE49-F238E27FC236}">
                  <a16:creationId xmlns:a16="http://schemas.microsoft.com/office/drawing/2014/main" id="{FEEC4F61-7912-7653-A298-8CA22944D8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10542" y="592645"/>
              <a:ext cx="3880211" cy="2347431"/>
            </a:xfrm>
            <a:prstGeom prst="rect">
              <a:avLst/>
            </a:prstGeom>
          </p:spPr>
        </p:pic>
        <p:grpSp>
          <p:nvGrpSpPr>
            <p:cNvPr id="10" name="그룹 9">
              <a:extLst>
                <a:ext uri="{FF2B5EF4-FFF2-40B4-BE49-F238E27FC236}">
                  <a16:creationId xmlns:a16="http://schemas.microsoft.com/office/drawing/2014/main" id="{2D7CAA84-4358-90B8-0114-B1DCE6EB943E}"/>
                </a:ext>
              </a:extLst>
            </p:cNvPr>
            <p:cNvGrpSpPr/>
            <p:nvPr/>
          </p:nvGrpSpPr>
          <p:grpSpPr>
            <a:xfrm>
              <a:off x="1854383" y="485510"/>
              <a:ext cx="7787095" cy="4572866"/>
              <a:chOff x="610799" y="320918"/>
              <a:chExt cx="7787095" cy="4572866"/>
            </a:xfrm>
          </p:grpSpPr>
          <p:grpSp>
            <p:nvGrpSpPr>
              <p:cNvPr id="11" name="그룹 10">
                <a:extLst>
                  <a:ext uri="{FF2B5EF4-FFF2-40B4-BE49-F238E27FC236}">
                    <a16:creationId xmlns:a16="http://schemas.microsoft.com/office/drawing/2014/main" id="{7706CAEC-DC5B-F51F-AC78-4B3FECE3B90F}"/>
                  </a:ext>
                </a:extLst>
              </p:cNvPr>
              <p:cNvGrpSpPr/>
              <p:nvPr/>
            </p:nvGrpSpPr>
            <p:grpSpPr>
              <a:xfrm>
                <a:off x="610799" y="400426"/>
                <a:ext cx="3627826" cy="2170124"/>
                <a:chOff x="610799" y="400426"/>
                <a:chExt cx="3627826" cy="2170124"/>
              </a:xfrm>
            </p:grpSpPr>
            <p:grpSp>
              <p:nvGrpSpPr>
                <p:cNvPr id="25" name="그룹 24">
                  <a:extLst>
                    <a:ext uri="{FF2B5EF4-FFF2-40B4-BE49-F238E27FC236}">
                      <a16:creationId xmlns:a16="http://schemas.microsoft.com/office/drawing/2014/main" id="{F92D3DAC-DEEE-66A0-7137-2706E99E01B2}"/>
                    </a:ext>
                  </a:extLst>
                </p:cNvPr>
                <p:cNvGrpSpPr/>
                <p:nvPr/>
              </p:nvGrpSpPr>
              <p:grpSpPr>
                <a:xfrm>
                  <a:off x="683951" y="590550"/>
                  <a:ext cx="3554674" cy="1980000"/>
                  <a:chOff x="729671" y="718723"/>
                  <a:chExt cx="4265609" cy="2356678"/>
                </a:xfrm>
              </p:grpSpPr>
              <p:pic>
                <p:nvPicPr>
                  <p:cNvPr id="27" name="그림 26" descr="스케치, 그림, 도표이(가) 표시된 사진&#10;&#10;AI가 생성한 콘텐츠는 부정확할 수 있습니다.">
                    <a:extLst>
                      <a:ext uri="{FF2B5EF4-FFF2-40B4-BE49-F238E27FC236}">
                        <a16:creationId xmlns:a16="http://schemas.microsoft.com/office/drawing/2014/main" id="{BC7AFBB5-C339-31BB-6ED5-E9AAC64C116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-1" r="1259"/>
                  <a:stretch/>
                </p:blipFill>
                <p:spPr>
                  <a:xfrm>
                    <a:off x="729671" y="718723"/>
                    <a:ext cx="4265609" cy="2356678"/>
                  </a:xfrm>
                  <a:prstGeom prst="rect">
                    <a:avLst/>
                  </a:prstGeom>
                </p:spPr>
              </p:pic>
              <p:grpSp>
                <p:nvGrpSpPr>
                  <p:cNvPr id="28" name="그룹 27">
                    <a:extLst>
                      <a:ext uri="{FF2B5EF4-FFF2-40B4-BE49-F238E27FC236}">
                        <a16:creationId xmlns:a16="http://schemas.microsoft.com/office/drawing/2014/main" id="{9A3AF1DF-CD03-0082-F5D6-02F17793A2DD}"/>
                      </a:ext>
                    </a:extLst>
                  </p:cNvPr>
                  <p:cNvGrpSpPr/>
                  <p:nvPr/>
                </p:nvGrpSpPr>
                <p:grpSpPr>
                  <a:xfrm>
                    <a:off x="2050100" y="1073606"/>
                    <a:ext cx="703981" cy="386894"/>
                    <a:chOff x="2050100" y="1073606"/>
                    <a:chExt cx="703981" cy="386894"/>
                  </a:xfrm>
                </p:grpSpPr>
                <p:sp>
                  <p:nvSpPr>
                    <p:cNvPr id="32" name="화살표: 아래쪽 31">
                      <a:extLst>
                        <a:ext uri="{FF2B5EF4-FFF2-40B4-BE49-F238E27FC236}">
                          <a16:creationId xmlns:a16="http://schemas.microsoft.com/office/drawing/2014/main" id="{C9160049-F3D3-001E-1F36-C9C0D0551E8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324100" y="1289050"/>
                      <a:ext cx="107950" cy="171450"/>
                    </a:xfrm>
                    <a:prstGeom prst="downArrow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3" name="TextBox 32">
                      <a:extLst>
                        <a:ext uri="{FF2B5EF4-FFF2-40B4-BE49-F238E27FC236}">
                          <a16:creationId xmlns:a16="http://schemas.microsoft.com/office/drawing/2014/main" id="{CE109397-D377-5507-FF4A-FECB2AA6B4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0100" y="1073606"/>
                      <a:ext cx="703981" cy="2263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lic acid</a:t>
                      </a:r>
                      <a:endParaRPr lang="ko-KR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29" name="그룹 28">
                    <a:extLst>
                      <a:ext uri="{FF2B5EF4-FFF2-40B4-BE49-F238E27FC236}">
                        <a16:creationId xmlns:a16="http://schemas.microsoft.com/office/drawing/2014/main" id="{AA44E7C9-840F-2D7E-5C25-44B35D3729BA}"/>
                      </a:ext>
                    </a:extLst>
                  </p:cNvPr>
                  <p:cNvGrpSpPr/>
                  <p:nvPr/>
                </p:nvGrpSpPr>
                <p:grpSpPr>
                  <a:xfrm>
                    <a:off x="2754072" y="1649868"/>
                    <a:ext cx="626565" cy="386894"/>
                    <a:chOff x="2754072" y="1649868"/>
                    <a:chExt cx="626565" cy="386894"/>
                  </a:xfrm>
                </p:grpSpPr>
                <p:sp>
                  <p:nvSpPr>
                    <p:cNvPr id="30" name="화살표: 아래쪽 29">
                      <a:extLst>
                        <a:ext uri="{FF2B5EF4-FFF2-40B4-BE49-F238E27FC236}">
                          <a16:creationId xmlns:a16="http://schemas.microsoft.com/office/drawing/2014/main" id="{B9C08AFC-1708-FB27-822C-E3AE47BEA26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41650" y="1865312"/>
                      <a:ext cx="107950" cy="171450"/>
                    </a:xfrm>
                    <a:prstGeom prst="downArrow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1" name="TextBox 30">
                      <a:extLst>
                        <a:ext uri="{FF2B5EF4-FFF2-40B4-BE49-F238E27FC236}">
                          <a16:creationId xmlns:a16="http://schemas.microsoft.com/office/drawing/2014/main" id="{36182499-603A-74F3-40D0-3C8C0150018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54072" y="1649868"/>
                      <a:ext cx="626565" cy="2263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rgenin</a:t>
                      </a:r>
                      <a:endParaRPr lang="ko-KR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27DB3757-25BA-C9D4-3101-35C5E25974D2}"/>
                    </a:ext>
                  </a:extLst>
                </p:cNvPr>
                <p:cNvSpPr txBox="1"/>
                <p:nvPr/>
              </p:nvSpPr>
              <p:spPr>
                <a:xfrm>
                  <a:off x="610799" y="400426"/>
                  <a:ext cx="355834" cy="24452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A)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2" name="그룹 11">
                <a:extLst>
                  <a:ext uri="{FF2B5EF4-FFF2-40B4-BE49-F238E27FC236}">
                    <a16:creationId xmlns:a16="http://schemas.microsoft.com/office/drawing/2014/main" id="{02272B1D-0CCD-384D-B0B2-22DDCEC9D347}"/>
                  </a:ext>
                </a:extLst>
              </p:cNvPr>
              <p:cNvGrpSpPr/>
              <p:nvPr/>
            </p:nvGrpSpPr>
            <p:grpSpPr>
              <a:xfrm>
                <a:off x="638231" y="2593369"/>
                <a:ext cx="3691440" cy="2186049"/>
                <a:chOff x="638231" y="2593369"/>
                <a:chExt cx="3691440" cy="2186049"/>
              </a:xfrm>
            </p:grpSpPr>
            <p:grpSp>
              <p:nvGrpSpPr>
                <p:cNvPr id="16" name="그룹 15">
                  <a:extLst>
                    <a:ext uri="{FF2B5EF4-FFF2-40B4-BE49-F238E27FC236}">
                      <a16:creationId xmlns:a16="http://schemas.microsoft.com/office/drawing/2014/main" id="{CA404FFF-B0FD-1BD3-5518-797D7A1C6888}"/>
                    </a:ext>
                  </a:extLst>
                </p:cNvPr>
                <p:cNvGrpSpPr/>
                <p:nvPr/>
              </p:nvGrpSpPr>
              <p:grpSpPr>
                <a:xfrm>
                  <a:off x="729671" y="2799418"/>
                  <a:ext cx="3600000" cy="1980000"/>
                  <a:chOff x="729671" y="3250268"/>
                  <a:chExt cx="4320000" cy="2388009"/>
                </a:xfrm>
              </p:grpSpPr>
              <p:pic>
                <p:nvPicPr>
                  <p:cNvPr id="18" name="그림 17" descr="도표, 그림, 스케치, 텍스트이(가) 표시된 사진&#10;&#10;AI가 생성한 콘텐츠는 부정확할 수 있습니다.">
                    <a:extLst>
                      <a:ext uri="{FF2B5EF4-FFF2-40B4-BE49-F238E27FC236}">
                        <a16:creationId xmlns:a16="http://schemas.microsoft.com/office/drawing/2014/main" id="{6AEA8E6C-ED3C-3D76-4917-1E022E061D3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29671" y="3250268"/>
                    <a:ext cx="4320000" cy="2388009"/>
                  </a:xfrm>
                  <a:prstGeom prst="rect">
                    <a:avLst/>
                  </a:prstGeom>
                </p:spPr>
              </p:pic>
              <p:grpSp>
                <p:nvGrpSpPr>
                  <p:cNvPr id="19" name="그룹 18">
                    <a:extLst>
                      <a:ext uri="{FF2B5EF4-FFF2-40B4-BE49-F238E27FC236}">
                        <a16:creationId xmlns:a16="http://schemas.microsoft.com/office/drawing/2014/main" id="{520EF035-47A4-D1F1-DFB9-F11067A9B4B6}"/>
                      </a:ext>
                    </a:extLst>
                  </p:cNvPr>
                  <p:cNvGrpSpPr/>
                  <p:nvPr/>
                </p:nvGrpSpPr>
                <p:grpSpPr>
                  <a:xfrm>
                    <a:off x="2803718" y="4077667"/>
                    <a:ext cx="626565" cy="366605"/>
                    <a:chOff x="2803718" y="1670157"/>
                    <a:chExt cx="626565" cy="366605"/>
                  </a:xfrm>
                </p:grpSpPr>
                <p:sp>
                  <p:nvSpPr>
                    <p:cNvPr id="23" name="화살표: 아래쪽 22">
                      <a:extLst>
                        <a:ext uri="{FF2B5EF4-FFF2-40B4-BE49-F238E27FC236}">
                          <a16:creationId xmlns:a16="http://schemas.microsoft.com/office/drawing/2014/main" id="{B75350A7-5529-5C1A-8F4F-C3884C3B44D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41650" y="1865312"/>
                      <a:ext cx="107950" cy="171450"/>
                    </a:xfrm>
                    <a:prstGeom prst="downArrow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4" name="TextBox 23">
                      <a:extLst>
                        <a:ext uri="{FF2B5EF4-FFF2-40B4-BE49-F238E27FC236}">
                          <a16:creationId xmlns:a16="http://schemas.microsoft.com/office/drawing/2014/main" id="{7A0325E5-52C1-4F94-CD65-136E136101B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803718" y="1670157"/>
                      <a:ext cx="626565" cy="22937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rgenin</a:t>
                      </a:r>
                      <a:endParaRPr lang="ko-KR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20" name="그룹 19">
                    <a:extLst>
                      <a:ext uri="{FF2B5EF4-FFF2-40B4-BE49-F238E27FC236}">
                        <a16:creationId xmlns:a16="http://schemas.microsoft.com/office/drawing/2014/main" id="{CFB446DE-4575-C1B7-DB77-94B1235CEF59}"/>
                      </a:ext>
                    </a:extLst>
                  </p:cNvPr>
                  <p:cNvGrpSpPr/>
                  <p:nvPr/>
                </p:nvGrpSpPr>
                <p:grpSpPr>
                  <a:xfrm>
                    <a:off x="2050099" y="4566106"/>
                    <a:ext cx="703981" cy="386894"/>
                    <a:chOff x="2050100" y="1073606"/>
                    <a:chExt cx="703981" cy="386894"/>
                  </a:xfrm>
                </p:grpSpPr>
                <p:sp>
                  <p:nvSpPr>
                    <p:cNvPr id="21" name="화살표: 아래쪽 20">
                      <a:extLst>
                        <a:ext uri="{FF2B5EF4-FFF2-40B4-BE49-F238E27FC236}">
                          <a16:creationId xmlns:a16="http://schemas.microsoft.com/office/drawing/2014/main" id="{903A4697-CAEA-02CA-FBC2-1F616D7C1FB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324100" y="1289050"/>
                      <a:ext cx="107950" cy="171450"/>
                    </a:xfrm>
                    <a:prstGeom prst="downArrow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2" name="TextBox 21">
                      <a:extLst>
                        <a:ext uri="{FF2B5EF4-FFF2-40B4-BE49-F238E27FC236}">
                          <a16:creationId xmlns:a16="http://schemas.microsoft.com/office/drawing/2014/main" id="{FC799F0C-0C50-1D0F-23FC-55020E07C9E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0100" y="1073606"/>
                      <a:ext cx="703981" cy="22937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lic acid</a:t>
                      </a:r>
                      <a:endParaRPr lang="ko-KR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E819365A-A076-11C1-A49E-23CA38539C8B}"/>
                    </a:ext>
                  </a:extLst>
                </p:cNvPr>
                <p:cNvSpPr txBox="1"/>
                <p:nvPr/>
              </p:nvSpPr>
              <p:spPr>
                <a:xfrm>
                  <a:off x="638231" y="2593369"/>
                  <a:ext cx="348664" cy="24452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B)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13" name="그림 12" descr="도표, 라인, 평행, 기술 도면이(가) 표시된 사진&#10;&#10;AI가 생성한 콘텐츠는 부정확할 수 있습니다.">
                <a:extLst>
                  <a:ext uri="{FF2B5EF4-FFF2-40B4-BE49-F238E27FC236}">
                    <a16:creationId xmlns:a16="http://schemas.microsoft.com/office/drawing/2014/main" id="{8FDE23B1-7D29-B99C-B05F-59CA6FCA20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50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21111" y="2685052"/>
                <a:ext cx="3976783" cy="2208732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4FB2B3D-94C9-5C46-2EAF-F6116EC83927}"/>
                  </a:ext>
                </a:extLst>
              </p:cNvPr>
              <p:cNvSpPr txBox="1"/>
              <p:nvPr/>
            </p:nvSpPr>
            <p:spPr>
              <a:xfrm>
                <a:off x="4370386" y="320918"/>
                <a:ext cx="355834" cy="2445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)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3723DF6-0EFB-886D-8028-3E72699D2C98}"/>
                  </a:ext>
                </a:extLst>
              </p:cNvPr>
              <p:cNvSpPr txBox="1"/>
              <p:nvPr/>
            </p:nvSpPr>
            <p:spPr>
              <a:xfrm>
                <a:off x="4370386" y="2522419"/>
                <a:ext cx="355834" cy="2445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D)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722825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99B78DB-198E-D61A-DBD4-B53B41F556F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681D69A-803F-BB81-12AB-B61D81320969}"/>
              </a:ext>
            </a:extLst>
          </p:cNvPr>
          <p:cNvSpPr txBox="1"/>
          <p:nvPr/>
        </p:nvSpPr>
        <p:spPr>
          <a:xfrm>
            <a:off x="1936679" y="4808196"/>
            <a:ext cx="870693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1" indent="-457200" algn="just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-MS chromatogram of the ethyl acetate (</a:t>
            </a:r>
            <a:r>
              <a:rPr lang="en-US" altLang="ko-K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tOAc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raction derived from </a:t>
            </a:r>
            <a:r>
              <a:rPr lang="en-US" altLang="ko-KR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ilboides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ularis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oot extract, highlighting its phytochemical complexity. Adapted from Yoo et al.,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es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25, 30, 1892.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 descr="스케치, 그림이(가) 표시된 사진&#10;&#10;AI가 생성한 콘텐츠는 부정확할 수 있습니다.">
            <a:extLst>
              <a:ext uri="{FF2B5EF4-FFF2-40B4-BE49-F238E27FC236}">
                <a16:creationId xmlns:a16="http://schemas.microsoft.com/office/drawing/2014/main" id="{1EF207F7-44F7-6637-E4EE-9081C0C0D8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54"/>
          <a:stretch/>
        </p:blipFill>
        <p:spPr>
          <a:xfrm>
            <a:off x="1848397" y="893337"/>
            <a:ext cx="8539187" cy="3914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29941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3C41AE6-FE03-02F8-ACDC-B961DB5112A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C0D25BDE-447C-FC6E-243D-3845C538A4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0080008"/>
              </p:ext>
            </p:extLst>
          </p:nvPr>
        </p:nvGraphicFramePr>
        <p:xfrm>
          <a:off x="914400" y="2393030"/>
          <a:ext cx="10543032" cy="19412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07834">
                  <a:extLst>
                    <a:ext uri="{9D8B030D-6E8A-4147-A177-3AD203B41FA5}">
                      <a16:colId xmlns:a16="http://schemas.microsoft.com/office/drawing/2014/main" val="3110282842"/>
                    </a:ext>
                  </a:extLst>
                </a:gridCol>
                <a:gridCol w="2997609">
                  <a:extLst>
                    <a:ext uri="{9D8B030D-6E8A-4147-A177-3AD203B41FA5}">
                      <a16:colId xmlns:a16="http://schemas.microsoft.com/office/drawing/2014/main" val="4065963767"/>
                    </a:ext>
                  </a:extLst>
                </a:gridCol>
                <a:gridCol w="2119309">
                  <a:extLst>
                    <a:ext uri="{9D8B030D-6E8A-4147-A177-3AD203B41FA5}">
                      <a16:colId xmlns:a16="http://schemas.microsoft.com/office/drawing/2014/main" val="780904279"/>
                    </a:ext>
                  </a:extLst>
                </a:gridCol>
                <a:gridCol w="1909140">
                  <a:extLst>
                    <a:ext uri="{9D8B030D-6E8A-4147-A177-3AD203B41FA5}">
                      <a16:colId xmlns:a16="http://schemas.microsoft.com/office/drawing/2014/main" val="3188279278"/>
                    </a:ext>
                  </a:extLst>
                </a:gridCol>
                <a:gridCol w="1909140">
                  <a:extLst>
                    <a:ext uri="{9D8B030D-6E8A-4147-A177-3AD203B41FA5}">
                      <a16:colId xmlns:a16="http://schemas.microsoft.com/office/drawing/2014/main" val="4164879675"/>
                    </a:ext>
                  </a:extLst>
                </a:gridCol>
              </a:tblGrid>
              <a:tr h="938827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unds</a:t>
                      </a:r>
                      <a:endParaRPr lang="ko-KR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ibration curve</a:t>
                      </a:r>
                      <a:endParaRPr lang="ko-KR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</a:t>
                      </a:r>
                      <a:endParaRPr lang="ko-KR" sz="1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R</a:t>
                      </a:r>
                      <a:r>
                        <a:rPr lang="en-US" sz="16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tention Time (min)</a:t>
                      </a:r>
                      <a:endParaRPr lang="ko-KR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ent</a:t>
                      </a:r>
                      <a:endParaRPr lang="ko-KR" sz="16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zh-CN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㎎</a:t>
                      </a: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g·Ext)</a:t>
                      </a:r>
                      <a:endParaRPr lang="ko-KR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5677688"/>
                  </a:ext>
                </a:extLst>
              </a:tr>
              <a:tr h="501199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lic acid</a:t>
                      </a:r>
                      <a:endParaRPr lang="ko-KR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21.34153X - 96.99437</a:t>
                      </a:r>
                      <a:endParaRPr lang="ko-KR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33</a:t>
                      </a:r>
                      <a:endParaRPr lang="ko-KR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25</a:t>
                      </a:r>
                      <a:endParaRPr lang="ko-KR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75±0.10</a:t>
                      </a:r>
                      <a:endParaRPr lang="ko-KR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6644471"/>
                  </a:ext>
                </a:extLst>
              </a:tr>
              <a:tr h="501199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rgenin</a:t>
                      </a:r>
                      <a:endParaRPr lang="ko-KR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10.29642X – 44.28700</a:t>
                      </a:r>
                      <a:endParaRPr lang="ko-KR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40</a:t>
                      </a:r>
                      <a:endParaRPr lang="ko-KR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375</a:t>
                      </a:r>
                      <a:endParaRPr lang="ko-KR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3.12±0.52</a:t>
                      </a:r>
                      <a:endParaRPr lang="ko-KR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3016377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D6C0E137-BF57-919A-55A5-938DABC5FB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635" y="1466573"/>
            <a:ext cx="10611797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analysis of major phytochemicals identified in the </a:t>
            </a:r>
            <a:r>
              <a:rPr lang="en-US" altLang="ko-K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tOAc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ction of </a:t>
            </a:r>
            <a:r>
              <a:rPr lang="en-US" altLang="ko-KR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ilboides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ularis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oot extract. Gallic acid and </a:t>
            </a:r>
            <a:r>
              <a:rPr lang="en-US" altLang="ko-K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rgenin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confirmed as the principal bioactive compounds based on LC-MS/MS and HPLC analysis. Data adapted from Yoo et al.,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es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25, 30, 1892</a:t>
            </a:r>
            <a:endParaRPr kumimoji="0" lang="en-US" altLang="ko-KR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6618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2</TotalTime>
  <Words>186</Words>
  <Application>Microsoft Office PowerPoint</Application>
  <PresentationFormat>와이드스크린</PresentationFormat>
  <Paragraphs>28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남호 유</dc:creator>
  <cp:lastModifiedBy>남호 유</cp:lastModifiedBy>
  <cp:revision>119</cp:revision>
  <dcterms:created xsi:type="dcterms:W3CDTF">2025-03-13T10:01:05Z</dcterms:created>
  <dcterms:modified xsi:type="dcterms:W3CDTF">2025-06-07T08:42:17Z</dcterms:modified>
</cp:coreProperties>
</file>